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9" d="100"/>
          <a:sy n="69" d="100"/>
        </p:scale>
        <p:origin x="-145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090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625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89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296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649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577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682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798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657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072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943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CC102-186B-EE4D-91B9-5BB521FFDDF9}" type="datetimeFigureOut">
              <a:rPr lang="en-US" smtClean="0"/>
              <a:t>3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6CEE2-13C8-D449-BF35-C42FCED4B3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43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88622" y="6167809"/>
            <a:ext cx="745066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Figure S5</a:t>
            </a:r>
            <a:r>
              <a:rPr lang="en-US" sz="1000" dirty="0">
                <a:latin typeface="Arial"/>
                <a:cs typeface="Arial"/>
              </a:rPr>
              <a:t>   Chromosome wide distribution of crossover counts for wild type (green) and </a:t>
            </a:r>
            <a:r>
              <a:rPr lang="en-US" sz="1000" i="1" dirty="0">
                <a:latin typeface="Arial"/>
                <a:cs typeface="Arial"/>
              </a:rPr>
              <a:t>mlh3</a:t>
            </a:r>
            <a:r>
              <a:rPr lang="en-US" sz="1000" i="1" dirty="0">
                <a:latin typeface="Arial"/>
                <a:cs typeface="Arial"/>
                <a:sym typeface="Symbol"/>
              </a:rPr>
              <a:t></a:t>
            </a:r>
            <a:r>
              <a:rPr lang="en-US" sz="1000" dirty="0">
                <a:latin typeface="Arial"/>
                <a:cs typeface="Arial"/>
              </a:rPr>
              <a:t> (red).  Actual crossover counts were divided by the number of tetrads to get normalized counts.  Chromosome size is shown in base pairs.</a:t>
            </a:r>
          </a:p>
        </p:txBody>
      </p:sp>
      <p:pic>
        <p:nvPicPr>
          <p:cNvPr id="2" name="Picture 2" descr="C:\Users\Nishant KT\Desktop\G3_March 7\Supplementary Figures_edited\newCodit\mlh3.CO_distribution_wo_circle.05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2275" y="730250"/>
            <a:ext cx="5757863" cy="5397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4295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jith V P</dc:creator>
  <cp:lastModifiedBy>Nishant KT</cp:lastModifiedBy>
  <cp:revision>4</cp:revision>
  <dcterms:created xsi:type="dcterms:W3CDTF">2017-03-07T07:26:46Z</dcterms:created>
  <dcterms:modified xsi:type="dcterms:W3CDTF">2017-03-08T06:08:27Z</dcterms:modified>
</cp:coreProperties>
</file>